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38460" y="8382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57600" y="8382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86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978" y="1275762"/>
            <a:ext cx="2819262" cy="31683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185" y="1296319"/>
            <a:ext cx="2776451" cy="3168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" y="4748842"/>
            <a:ext cx="2874376" cy="31725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38460" y="44651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Rectangle 8"/>
          <p:cNvSpPr/>
          <p:nvPr/>
        </p:nvSpPr>
        <p:spPr>
          <a:xfrm>
            <a:off x="3440548" y="4948285"/>
            <a:ext cx="2913120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2 Fig.  Assessment of the purity of isolated mouse cells used in this work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 cell population were negatively isolated from splenocytes and analyzed by flow cytometer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ritoneal cells were isolated and cultured in DMEM with 20 ng/ml M-CSF for 6 h and the adherent cells were harvest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tripperan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zed by flow cytometer.  Numbers indicate the percentage of gated cells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sting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 lymphocytes were further isolated from total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 cells and identified by flow cytometer using anti-CD69, anti-CD25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669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3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2</cp:revision>
  <dcterms:created xsi:type="dcterms:W3CDTF">2018-05-11T18:35:20Z</dcterms:created>
  <dcterms:modified xsi:type="dcterms:W3CDTF">2018-05-11T18:37:01Z</dcterms:modified>
</cp:coreProperties>
</file>